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  <p:sldMasterId id="2147483684" r:id="rId2"/>
  </p:sldMasterIdLst>
  <p:sldIdLst>
    <p:sldId id="261" r:id="rId3"/>
    <p:sldId id="262" r:id="rId4"/>
    <p:sldId id="263" r:id="rId5"/>
    <p:sldId id="273" r:id="rId6"/>
    <p:sldId id="274" r:id="rId7"/>
    <p:sldId id="276" r:id="rId8"/>
    <p:sldId id="259" r:id="rId9"/>
    <p:sldId id="283" r:id="rId10"/>
    <p:sldId id="264" r:id="rId11"/>
    <p:sldId id="280" r:id="rId12"/>
    <p:sldId id="282" r:id="rId13"/>
    <p:sldId id="281" r:id="rId1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e, Keunsub [BIOTC]" initials="LK[" lastIdx="2" clrIdx="0">
    <p:extLst>
      <p:ext uri="{19B8F6BF-5375-455C-9EA6-DF929625EA0E}">
        <p15:presenceInfo xmlns:p15="http://schemas.microsoft.com/office/powerpoint/2012/main" userId="S-1-5-21-1659004503-1450960922-1606980848-277169" providerId="AD"/>
      </p:ext>
    </p:extLst>
  </p:cmAuthor>
  <p:cmAuthor id="2" name="Microsoft Office User" initials="MOU" lastIdx="1" clrIdx="1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/>
    <p:restoredTop sz="94646"/>
  </p:normalViewPr>
  <p:slideViewPr>
    <p:cSldViewPr snapToGrid="0" snapToObjects="1">
      <p:cViewPr varScale="1">
        <p:scale>
          <a:sx n="75" d="100"/>
          <a:sy n="75" d="100"/>
        </p:scale>
        <p:origin x="188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commentAuthors" Target="commentAuthors.xml"/><Relationship Id="rId10" Type="http://schemas.openxmlformats.org/officeDocument/2006/relationships/slide" Target="slides/slide8.xml"/><Relationship Id="rId19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imee\Box%20Sync\3.16_Cpf1%20genome%20editing%20system\Cpf1%20genome%20editing%20in%20Arabidopsis\Powerpoints\rflp%20analysis%20of%20408%20late%20heat%20treatmen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imee\Box\3.27%20Temperature%20sensitive%20genome%20editing%20with%20Cpf1\Manuscript%20prep\Cq%20final%20(2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iping%20Qi\Box%20Sync\1.%20Lab%20projects\3.27%20Temperature%20sensitive%20genome%20editing%20with%20Cpf1\Manuscript%20prep\BMC%20Biology\For%20revision\Cpf1%20qRT%20Summary%20-%20Analysis%20Result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iping%20Qi\Box%20Sync\1.%20Lab%20projects\3.27%20Temperature%20sensitive%20genome%20editing%20with%20Cpf1\Manuscript%20prep\BMC%20Biology\For%20revision\Cpf1%20qRT%20Summary%20-%20Analysis%20Result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iping%20Qi\Box%20Sync\1.%20Lab%20projects\3.27%20Temperature%20sensitive%20genome%20editing%20with%20Cpf1\Manuscript%20prep\BMC%20Biology\For%20revision\Cpf1%20qRT%20Summary%20-%20Analysis%20Result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14214670534604"/>
          <c:y val="0.16708333333333336"/>
          <c:w val="0.5243357392825897"/>
          <c:h val="0.720887649460484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A$2,Sheet1!$D$2)</c:f>
              <c:strCache>
                <c:ptCount val="2"/>
                <c:pt idx="0">
                  <c:v>GL2 #7</c:v>
                </c:pt>
                <c:pt idx="1">
                  <c:v>GL2 #8</c:v>
                </c:pt>
              </c:strCache>
            </c:strRef>
          </c:cat>
          <c:val>
            <c:numRef>
              <c:f>(Sheet1!$B$19,Sheet1!$E$19)</c:f>
              <c:numCache>
                <c:formatCode>General</c:formatCode>
                <c:ptCount val="2"/>
                <c:pt idx="0">
                  <c:v>2.35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04-4267-BFC4-88A3F7D14F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4050400"/>
        <c:axId val="194050960"/>
      </c:barChart>
      <c:catAx>
        <c:axId val="194050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4050960"/>
        <c:crosses val="autoZero"/>
        <c:auto val="1"/>
        <c:lblAlgn val="ctr"/>
        <c:lblOffset val="100"/>
        <c:noMultiLvlLbl val="0"/>
      </c:catAx>
      <c:valAx>
        <c:axId val="194050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% </a:t>
                </a: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Mut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4050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dirty="0">
                <a:solidFill>
                  <a:schemeClr val="tx1"/>
                </a:solidFill>
              </a:rPr>
              <a:t>Mutation % by LbCas12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Mutation %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3:$E$4</c:f>
                <c:numCache>
                  <c:formatCode>General</c:formatCode>
                  <c:ptCount val="2"/>
                  <c:pt idx="0">
                    <c:v>9.9999999999999867E-2</c:v>
                  </c:pt>
                  <c:pt idx="1">
                    <c:v>0.14999999999999991</c:v>
                  </c:pt>
                </c:numCache>
              </c:numRef>
            </c:plus>
            <c:minus>
              <c:numRef>
                <c:f>Sheet1!$E$3:$E$4</c:f>
                <c:numCache>
                  <c:formatCode>General</c:formatCode>
                  <c:ptCount val="2"/>
                  <c:pt idx="0">
                    <c:v>9.9999999999999867E-2</c:v>
                  </c:pt>
                  <c:pt idx="1">
                    <c:v>0.149999999999999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:$A$4</c:f>
              <c:strCache>
                <c:ptCount val="2"/>
                <c:pt idx="0">
                  <c:v>22℃</c:v>
                </c:pt>
                <c:pt idx="1">
                  <c:v>29℃</c:v>
                </c:pt>
              </c:strCache>
            </c:strRef>
          </c:cat>
          <c:val>
            <c:numRef>
              <c:f>Sheet1!$B$3:$B$4</c:f>
              <c:numCache>
                <c:formatCode>General</c:formatCode>
                <c:ptCount val="2"/>
                <c:pt idx="0">
                  <c:v>2.7</c:v>
                </c:pt>
                <c:pt idx="1">
                  <c:v>3.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C2-2A41-A5E0-57D58FBA19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02364767"/>
        <c:axId val="1279630639"/>
      </c:barChart>
      <c:catAx>
        <c:axId val="13023647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9630639"/>
        <c:crosses val="autoZero"/>
        <c:auto val="1"/>
        <c:lblAlgn val="ctr"/>
        <c:lblOffset val="100"/>
        <c:noMultiLvlLbl val="0"/>
      </c:catAx>
      <c:valAx>
        <c:axId val="1279630639"/>
        <c:scaling>
          <c:orientation val="minMax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02364767"/>
        <c:crosses val="autoZero"/>
        <c:crossBetween val="between"/>
        <c:majorUnit val="1"/>
        <c:min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48381452318461"/>
          <c:y val="5.0925925925925923E-2"/>
          <c:w val="0.555071741032371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AP1 expression'!$AA$14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P1 expression'!$AB$16:$AD$16</c:f>
                <c:numCache>
                  <c:formatCode>General</c:formatCode>
                  <c:ptCount val="3"/>
                  <c:pt idx="0">
                    <c:v>2.5964204069638352</c:v>
                  </c:pt>
                  <c:pt idx="1">
                    <c:v>3.094602748764228</c:v>
                  </c:pt>
                  <c:pt idx="2">
                    <c:v>1.2663064941880791</c:v>
                  </c:pt>
                </c:numCache>
              </c:numRef>
            </c:plus>
            <c:minus>
              <c:numRef>
                <c:f>'PAP1 expression'!$AB$16:$AD$16</c:f>
                <c:numCache>
                  <c:formatCode>General</c:formatCode>
                  <c:ptCount val="3"/>
                  <c:pt idx="0">
                    <c:v>2.5964204069638352</c:v>
                  </c:pt>
                  <c:pt idx="1">
                    <c:v>3.094602748764228</c:v>
                  </c:pt>
                  <c:pt idx="2">
                    <c:v>1.26630649418807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P1 expression'!$AB$13:$AD$13</c:f>
              <c:strCache>
                <c:ptCount val="3"/>
                <c:pt idx="0">
                  <c:v>WT 16 °C</c:v>
                </c:pt>
                <c:pt idx="1">
                  <c:v>WT 22 °C</c:v>
                </c:pt>
                <c:pt idx="2">
                  <c:v>WT 29 °C</c:v>
                </c:pt>
              </c:strCache>
            </c:strRef>
          </c:cat>
          <c:val>
            <c:numRef>
              <c:f>'PAP1 expression'!$AB$14:$AD$14</c:f>
              <c:numCache>
                <c:formatCode>General</c:formatCode>
                <c:ptCount val="3"/>
                <c:pt idx="0">
                  <c:v>35.310532100030002</c:v>
                </c:pt>
                <c:pt idx="1">
                  <c:v>34.701857791682812</c:v>
                </c:pt>
                <c:pt idx="2">
                  <c:v>30.417372527594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A78-43D1-AD25-627BE95250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4053200"/>
        <c:axId val="194053760"/>
      </c:barChart>
      <c:catAx>
        <c:axId val="194053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4053760"/>
        <c:crosses val="autoZero"/>
        <c:auto val="1"/>
        <c:lblAlgn val="ctr"/>
        <c:lblOffset val="100"/>
        <c:noMultiLvlLbl val="0"/>
      </c:catAx>
      <c:valAx>
        <c:axId val="19405376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q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40532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/>
              <a:t>16°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s!$N$9:$O$9</c:f>
                <c:numCache>
                  <c:formatCode>General</c:formatCode>
                  <c:ptCount val="2"/>
                  <c:pt idx="0">
                    <c:v>2.9129980797736721</c:v>
                  </c:pt>
                  <c:pt idx="1">
                    <c:v>0.3024573233820157</c:v>
                  </c:pt>
                </c:numCache>
              </c:numRef>
            </c:plus>
            <c:minus>
              <c:numRef>
                <c:f>Graphs!$N$9:$O$9</c:f>
                <c:numCache>
                  <c:formatCode>General</c:formatCode>
                  <c:ptCount val="2"/>
                  <c:pt idx="0">
                    <c:v>2.9129980797736721</c:v>
                  </c:pt>
                  <c:pt idx="1">
                    <c:v>0.30245732338201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aphs!$N$6:$O$6</c:f>
              <c:strCache>
                <c:ptCount val="2"/>
                <c:pt idx="0">
                  <c:v>PAP1 #1</c:v>
                </c:pt>
                <c:pt idx="1">
                  <c:v>PAP1 #2</c:v>
                </c:pt>
              </c:strCache>
            </c:strRef>
          </c:cat>
          <c:val>
            <c:numRef>
              <c:f>Graphs!$N$7:$O$7</c:f>
              <c:numCache>
                <c:formatCode>General</c:formatCode>
                <c:ptCount val="2"/>
                <c:pt idx="0">
                  <c:v>25.166675199305054</c:v>
                </c:pt>
                <c:pt idx="1">
                  <c:v>12.2586438742944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3D-4C4F-A42B-FF0E6FAB58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7244111"/>
        <c:axId val="827244943"/>
      </c:barChart>
      <c:catAx>
        <c:axId val="8272441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7244943"/>
        <c:crosses val="autoZero"/>
        <c:auto val="1"/>
        <c:lblAlgn val="ctr"/>
        <c:lblOffset val="100"/>
        <c:noMultiLvlLbl val="0"/>
      </c:catAx>
      <c:valAx>
        <c:axId val="827244943"/>
        <c:scaling>
          <c:orientation val="minMax"/>
          <c:max val="3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q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72441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0" i="0" baseline="0">
                <a:effectLst/>
              </a:rPr>
              <a:t>22°C</a:t>
            </a:r>
            <a:endParaRPr lang="en-US" sz="16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s!$P$9:$Q$9</c:f>
                <c:numCache>
                  <c:formatCode>General</c:formatCode>
                  <c:ptCount val="2"/>
                  <c:pt idx="0">
                    <c:v>1.2687952463368386</c:v>
                  </c:pt>
                  <c:pt idx="1">
                    <c:v>1.2299011567811453</c:v>
                  </c:pt>
                </c:numCache>
              </c:numRef>
            </c:plus>
            <c:minus>
              <c:numRef>
                <c:f>Graphs!$P$9:$Q$9</c:f>
                <c:numCache>
                  <c:formatCode>General</c:formatCode>
                  <c:ptCount val="2"/>
                  <c:pt idx="0">
                    <c:v>1.2687952463368386</c:v>
                  </c:pt>
                  <c:pt idx="1">
                    <c:v>1.22990115678114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aphs!$P$6:$Q$6</c:f>
              <c:strCache>
                <c:ptCount val="2"/>
                <c:pt idx="0">
                  <c:v>PAP1 #1</c:v>
                </c:pt>
                <c:pt idx="1">
                  <c:v>PAP1 #2</c:v>
                </c:pt>
              </c:strCache>
            </c:strRef>
          </c:cat>
          <c:val>
            <c:numRef>
              <c:f>Graphs!$P$7:$Q$7</c:f>
              <c:numCache>
                <c:formatCode>General</c:formatCode>
                <c:ptCount val="2"/>
                <c:pt idx="0">
                  <c:v>28.777929178546707</c:v>
                </c:pt>
                <c:pt idx="1">
                  <c:v>29.6725277629313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59-4F22-AE44-5E27C5796E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6667135"/>
        <c:axId val="656667551"/>
      </c:barChart>
      <c:catAx>
        <c:axId val="6566671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6667551"/>
        <c:crosses val="autoZero"/>
        <c:auto val="1"/>
        <c:lblAlgn val="ctr"/>
        <c:lblOffset val="100"/>
        <c:noMultiLvlLbl val="0"/>
      </c:catAx>
      <c:valAx>
        <c:axId val="656667551"/>
        <c:scaling>
          <c:orientation val="minMax"/>
          <c:max val="3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q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66671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0" i="0" baseline="0">
                <a:effectLst/>
              </a:rPr>
              <a:t>29°C</a:t>
            </a:r>
            <a:endParaRPr lang="en-US" sz="16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s!$R$9:$S$9</c:f>
                <c:numCache>
                  <c:formatCode>General</c:formatCode>
                  <c:ptCount val="2"/>
                  <c:pt idx="0">
                    <c:v>3.5337799009967013</c:v>
                  </c:pt>
                  <c:pt idx="1">
                    <c:v>1.5019087839020744</c:v>
                  </c:pt>
                </c:numCache>
              </c:numRef>
            </c:plus>
            <c:minus>
              <c:numRef>
                <c:f>Graphs!$R$9:$S$9</c:f>
                <c:numCache>
                  <c:formatCode>General</c:formatCode>
                  <c:ptCount val="2"/>
                  <c:pt idx="0">
                    <c:v>3.5337799009967013</c:v>
                  </c:pt>
                  <c:pt idx="1">
                    <c:v>1.50190878390207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aphs!$R$6:$S$6</c:f>
              <c:strCache>
                <c:ptCount val="2"/>
                <c:pt idx="0">
                  <c:v>PAP1 #1</c:v>
                </c:pt>
                <c:pt idx="1">
                  <c:v>PAP1 #2</c:v>
                </c:pt>
              </c:strCache>
            </c:strRef>
          </c:cat>
          <c:val>
            <c:numRef>
              <c:f>Graphs!$R$7:$S$7</c:f>
              <c:numCache>
                <c:formatCode>General</c:formatCode>
                <c:ptCount val="2"/>
                <c:pt idx="0">
                  <c:v>23.611421488254845</c:v>
                </c:pt>
                <c:pt idx="1">
                  <c:v>30.1482430049596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55-4F0E-8062-61B5FB2812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55192511"/>
        <c:axId val="755193343"/>
      </c:barChart>
      <c:catAx>
        <c:axId val="7551925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5193343"/>
        <c:crosses val="autoZero"/>
        <c:auto val="1"/>
        <c:lblAlgn val="ctr"/>
        <c:lblOffset val="100"/>
        <c:noMultiLvlLbl val="0"/>
      </c:catAx>
      <c:valAx>
        <c:axId val="755193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q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51925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52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551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1583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382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530"/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25611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6856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3"/>
            <a:ext cx="5915025" cy="3803649"/>
          </a:xfrm>
        </p:spPr>
        <p:txBody>
          <a:bodyPr anchor="b"/>
          <a:lstStyle>
            <a:lvl1pPr>
              <a:defRPr sz="382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7"/>
            <a:ext cx="5915025" cy="2000249"/>
          </a:xfrm>
        </p:spPr>
        <p:txBody>
          <a:bodyPr/>
          <a:lstStyle>
            <a:lvl1pPr marL="0" indent="0">
              <a:buNone/>
              <a:defRPr sz="1530">
                <a:solidFill>
                  <a:schemeClr val="tx1"/>
                </a:solidFill>
              </a:defRPr>
            </a:lvl1pPr>
            <a:lvl2pPr marL="291465" indent="0">
              <a:buNone/>
              <a:defRPr sz="1275">
                <a:solidFill>
                  <a:schemeClr val="tx1">
                    <a:tint val="75000"/>
                  </a:schemeClr>
                </a:solidFill>
              </a:defRPr>
            </a:lvl2pPr>
            <a:lvl3pPr marL="582930" indent="0">
              <a:buNone/>
              <a:defRPr sz="1148">
                <a:solidFill>
                  <a:schemeClr val="tx1">
                    <a:tint val="75000"/>
                  </a:schemeClr>
                </a:solidFill>
              </a:defRPr>
            </a:lvl3pPr>
            <a:lvl4pPr marL="874395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4pPr>
            <a:lvl5pPr marL="1165860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5pPr>
            <a:lvl6pPr marL="1457325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6pPr>
            <a:lvl7pPr marL="1748790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7pPr>
            <a:lvl8pPr marL="2040255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8pPr>
            <a:lvl9pPr marL="2331720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45570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76522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1"/>
            <a:ext cx="2901255" cy="1098549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1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1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94766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58336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35351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040"/>
            </a:lvl1pPr>
            <a:lvl2pPr>
              <a:defRPr sz="1785"/>
            </a:lvl2pPr>
            <a:lvl3pPr>
              <a:defRPr sz="1530"/>
            </a:lvl3pPr>
            <a:lvl4pPr>
              <a:defRPr sz="1275"/>
            </a:lvl4pPr>
            <a:lvl5pPr>
              <a:defRPr sz="1275"/>
            </a:lvl5pPr>
            <a:lvl6pPr>
              <a:defRPr sz="1275"/>
            </a:lvl6pPr>
            <a:lvl7pPr>
              <a:defRPr sz="1275"/>
            </a:lvl7pPr>
            <a:lvl8pPr>
              <a:defRPr sz="1275"/>
            </a:lvl8pPr>
            <a:lvl9pPr>
              <a:defRPr sz="127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795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3272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040"/>
            </a:lvl1pPr>
            <a:lvl2pPr marL="291465" indent="0">
              <a:buNone/>
              <a:defRPr sz="1785"/>
            </a:lvl2pPr>
            <a:lvl3pPr marL="582930" indent="0">
              <a:buNone/>
              <a:defRPr sz="1530"/>
            </a:lvl3pPr>
            <a:lvl4pPr marL="874395" indent="0">
              <a:buNone/>
              <a:defRPr sz="1275"/>
            </a:lvl4pPr>
            <a:lvl5pPr marL="1165860" indent="0">
              <a:buNone/>
              <a:defRPr sz="1275"/>
            </a:lvl5pPr>
            <a:lvl6pPr marL="1457325" indent="0">
              <a:buNone/>
              <a:defRPr sz="1275"/>
            </a:lvl6pPr>
            <a:lvl7pPr marL="1748790" indent="0">
              <a:buNone/>
              <a:defRPr sz="1275"/>
            </a:lvl7pPr>
            <a:lvl8pPr marL="2040255" indent="0">
              <a:buNone/>
              <a:defRPr sz="1275"/>
            </a:lvl8pPr>
            <a:lvl9pPr marL="2331720" indent="0">
              <a:buNone/>
              <a:defRPr sz="127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37044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7992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591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426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10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720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964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732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409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001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86676F-862C-3246-BD5A-39131F15D29A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A8D92E-0F94-6443-B8B1-81EFAD7B7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294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F1A118-827C-4250-916E-0D9E1C20AFD9}" type="datetimeFigureOut">
              <a:rPr lang="en-US" smtClean="0"/>
              <a:t>1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F82CB3-7616-4BFE-8E61-8F6E9FA97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177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82930" rtl="0" eaLnBrk="1" latinLnBrk="0" hangingPunct="1">
        <a:lnSpc>
          <a:spcPct val="90000"/>
        </a:lnSpc>
        <a:spcBef>
          <a:spcPct val="0"/>
        </a:spcBef>
        <a:buNone/>
        <a:defRPr sz="280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5733" indent="-145733" algn="l" defTabSz="582930" rtl="0" eaLnBrk="1" latinLnBrk="0" hangingPunct="1">
        <a:lnSpc>
          <a:spcPct val="90000"/>
        </a:lnSpc>
        <a:spcBef>
          <a:spcPts val="638"/>
        </a:spcBef>
        <a:buFont typeface="Arial" panose="020B0604020202020204" pitchFamily="34" charset="0"/>
        <a:buChar char="•"/>
        <a:defRPr sz="1785" kern="1200">
          <a:solidFill>
            <a:schemeClr val="tx1"/>
          </a:solidFill>
          <a:latin typeface="+mn-lt"/>
          <a:ea typeface="+mn-ea"/>
          <a:cs typeface="+mn-cs"/>
        </a:defRPr>
      </a:lvl1pPr>
      <a:lvl2pPr marL="43719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2866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3pPr>
      <a:lvl4pPr marL="102012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4pPr>
      <a:lvl5pPr marL="131159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5pPr>
      <a:lvl6pPr marL="160305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6pPr>
      <a:lvl7pPr marL="189452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7pPr>
      <a:lvl8pPr marL="218598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8pPr>
      <a:lvl9pPr marL="247745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1pPr>
      <a:lvl2pPr marL="29146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2pPr>
      <a:lvl3pPr marL="58293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3pPr>
      <a:lvl4pPr marL="87439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4pPr>
      <a:lvl5pPr marL="116586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5pPr>
      <a:lvl6pPr marL="145732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6pPr>
      <a:lvl7pPr marL="174879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7pPr>
      <a:lvl8pPr marL="204025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8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8.xml"/><Relationship Id="rId4" Type="http://schemas.openxmlformats.org/officeDocument/2006/relationships/chart" Target="../charts/char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18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tif"/><Relationship Id="rId5" Type="http://schemas.openxmlformats.org/officeDocument/2006/relationships/image" Target="../media/image13.tif"/><Relationship Id="rId4" Type="http://schemas.openxmlformats.org/officeDocument/2006/relationships/image" Target="../media/image12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1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18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FF260FAE-4931-ED40-BD89-1387518560FE}"/>
              </a:ext>
            </a:extLst>
          </p:cNvPr>
          <p:cNvSpPr txBox="1"/>
          <p:nvPr/>
        </p:nvSpPr>
        <p:spPr>
          <a:xfrm>
            <a:off x="170329" y="8164176"/>
            <a:ext cx="66876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. </a:t>
            </a:r>
            <a:r>
              <a:rPr lang="en-US" sz="1200" dirty="0"/>
              <a:t>RFLP analysis of nuclease activities of three Cas12a (Cpf1) nucleases in rice protoplasts under different temperatures</a:t>
            </a:r>
            <a:r>
              <a:rPr lang="en-US" sz="1200" b="1" dirty="0"/>
              <a:t>. </a:t>
            </a:r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) and (</a:t>
            </a:r>
            <a:r>
              <a:rPr lang="en-US" sz="1200" b="1" dirty="0"/>
              <a:t>b</a:t>
            </a:r>
            <a:r>
              <a:rPr lang="en-US" sz="1200" dirty="0"/>
              <a:t>) RFLP analysis of </a:t>
            </a:r>
            <a:r>
              <a:rPr lang="en-US" sz="1200" i="1" dirty="0"/>
              <a:t>OsDEP1</a:t>
            </a:r>
            <a:r>
              <a:rPr lang="en-US" sz="1200" dirty="0"/>
              <a:t> and </a:t>
            </a:r>
            <a:r>
              <a:rPr lang="en-US" sz="1200" i="1" dirty="0"/>
              <a:t>OsROC5</a:t>
            </a:r>
            <a:r>
              <a:rPr lang="en-US" sz="1200" dirty="0"/>
              <a:t> targeted by three Cas12a nucleases at four different temperatures. WT controls both with and without enzyme digestion were included.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333ABEF-815B-B242-9A3D-B61247A5581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34"/>
          <a:stretch/>
        </p:blipFill>
        <p:spPr>
          <a:xfrm>
            <a:off x="1081347" y="330831"/>
            <a:ext cx="3960000" cy="362733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4C1D235-EC10-A142-A453-577968F90FA1}"/>
              </a:ext>
            </a:extLst>
          </p:cNvPr>
          <p:cNvSpPr txBox="1"/>
          <p:nvPr/>
        </p:nvSpPr>
        <p:spPr>
          <a:xfrm>
            <a:off x="622256" y="218948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85B6D0-30D9-AB4E-9A87-E8E0B704EA32}"/>
              </a:ext>
            </a:extLst>
          </p:cNvPr>
          <p:cNvSpPr txBox="1"/>
          <p:nvPr/>
        </p:nvSpPr>
        <p:spPr>
          <a:xfrm>
            <a:off x="622256" y="433932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0D48706-AED9-436B-97EE-8AF5EE34D62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86" r="928"/>
          <a:stretch/>
        </p:blipFill>
        <p:spPr>
          <a:xfrm>
            <a:off x="1081347" y="4339325"/>
            <a:ext cx="3960000" cy="37094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544977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BA74563-4505-43AE-AD21-558725E25304}"/>
              </a:ext>
            </a:extLst>
          </p:cNvPr>
          <p:cNvSpPr txBox="1"/>
          <p:nvPr/>
        </p:nvSpPr>
        <p:spPr>
          <a:xfrm>
            <a:off x="323602" y="5989810"/>
            <a:ext cx="621079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0</a:t>
            </a:r>
            <a:r>
              <a:rPr lang="en-US" sz="1200" dirty="0"/>
              <a:t>. </a:t>
            </a:r>
            <a:r>
              <a:rPr lang="en-US" sz="1200" i="1" dirty="0"/>
              <a:t>PAP1</a:t>
            </a:r>
            <a:r>
              <a:rPr lang="en-US" sz="1200" dirty="0"/>
              <a:t> expression at three different temperatures in the GUS control plants (WT). </a:t>
            </a:r>
            <a:r>
              <a:rPr lang="en-US" sz="1200" i="1" dirty="0"/>
              <a:t>PAP1</a:t>
            </a:r>
            <a:r>
              <a:rPr lang="en-US" sz="1200" dirty="0"/>
              <a:t> expression was normalized to</a:t>
            </a:r>
            <a:r>
              <a:rPr lang="en-US" sz="1200" i="1" dirty="0"/>
              <a:t> EF1</a:t>
            </a:r>
            <a:r>
              <a:rPr lang="el-GR" sz="1200" i="1" dirty="0"/>
              <a:t>α</a:t>
            </a:r>
            <a:r>
              <a:rPr lang="en-US" sz="1200" dirty="0"/>
              <a:t> at 16° C, 22 °C, and 29 °C. Error bars represent standard errors of three biological replicates except for WT at 16 °C for which four biological replicates were used.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00000000-0008-0000-02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7832434"/>
              </p:ext>
            </p:extLst>
          </p:nvPr>
        </p:nvGraphicFramePr>
        <p:xfrm>
          <a:off x="1116280" y="113960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658041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00000000-0008-0000-01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8616329"/>
              </p:ext>
            </p:extLst>
          </p:nvPr>
        </p:nvGraphicFramePr>
        <p:xfrm>
          <a:off x="545744" y="987424"/>
          <a:ext cx="1606845" cy="2743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00000000-0008-0000-01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4706665"/>
              </p:ext>
            </p:extLst>
          </p:nvPr>
        </p:nvGraphicFramePr>
        <p:xfrm>
          <a:off x="2363508" y="987425"/>
          <a:ext cx="160684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0000000-0008-0000-01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2918537"/>
              </p:ext>
            </p:extLst>
          </p:nvPr>
        </p:nvGraphicFramePr>
        <p:xfrm>
          <a:off x="4320973" y="987423"/>
          <a:ext cx="160328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2295716-4B9D-40DF-B18A-D774C092E9FC}"/>
              </a:ext>
            </a:extLst>
          </p:cNvPr>
          <p:cNvSpPr txBox="1"/>
          <p:nvPr/>
        </p:nvSpPr>
        <p:spPr>
          <a:xfrm>
            <a:off x="323602" y="5343479"/>
            <a:ext cx="621079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1</a:t>
            </a:r>
            <a:r>
              <a:rPr lang="en-US" sz="1200" dirty="0"/>
              <a:t>. </a:t>
            </a:r>
            <a:r>
              <a:rPr lang="en-US" sz="1200" i="1" dirty="0"/>
              <a:t>dLbCas12a-SRDX</a:t>
            </a:r>
            <a:r>
              <a:rPr lang="en-US" sz="1200" dirty="0"/>
              <a:t> expression at three different temperatures in transgenic lines. </a:t>
            </a:r>
            <a:r>
              <a:rPr lang="en-US" sz="1200" i="1" dirty="0"/>
              <a:t>dLbCas12a-SRDX</a:t>
            </a:r>
            <a:r>
              <a:rPr lang="en-US" sz="1200" dirty="0"/>
              <a:t> expression was normalized to</a:t>
            </a:r>
            <a:r>
              <a:rPr lang="en-US" sz="1200" i="1" dirty="0"/>
              <a:t> EF1</a:t>
            </a:r>
            <a:r>
              <a:rPr lang="el-GR" sz="1200" i="1" dirty="0"/>
              <a:t>α</a:t>
            </a:r>
            <a:r>
              <a:rPr lang="en-US" sz="1200" dirty="0"/>
              <a:t> at 16° C, 22 °C, and 29 °C. Error bars represent standard errors of four biological replicates except for PAP1 #2 at 29 °C for which only three biological replicates were used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9688835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0B5D762-A613-2043-BE85-F6C22E46D2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8221940"/>
              </p:ext>
            </p:extLst>
          </p:nvPr>
        </p:nvGraphicFramePr>
        <p:xfrm>
          <a:off x="330200" y="2451100"/>
          <a:ext cx="6178550" cy="2933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Worksheet" r:id="rId3" imgW="4038600" imgH="1917700" progId="Excel.Sheet.12">
                  <p:embed/>
                </p:oleObj>
              </mc:Choice>
              <mc:Fallback>
                <p:oleObj name="Worksheet" r:id="rId3" imgW="4038600" imgH="19177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0200" y="2451100"/>
                        <a:ext cx="6178550" cy="2933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0984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086AC4B-C11A-A246-A117-67DCF7799A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2772" y="1283029"/>
            <a:ext cx="3600353" cy="195057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AFBD10B-ECFD-0146-B368-470DF10AD6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2773" y="3806639"/>
            <a:ext cx="3600353" cy="207181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BE5CA44-6236-9846-BD5C-D5AD8077981B}"/>
              </a:ext>
            </a:extLst>
          </p:cNvPr>
          <p:cNvSpPr txBox="1"/>
          <p:nvPr/>
        </p:nvSpPr>
        <p:spPr>
          <a:xfrm>
            <a:off x="5023125" y="2420471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licate 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575229E-2977-EA46-BC4E-AC47D6F24373}"/>
              </a:ext>
            </a:extLst>
          </p:cNvPr>
          <p:cNvSpPr txBox="1"/>
          <p:nvPr/>
        </p:nvSpPr>
        <p:spPr>
          <a:xfrm>
            <a:off x="5023125" y="5029200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licate 2</a:t>
            </a:r>
          </a:p>
        </p:txBody>
      </p:sp>
      <p:sp>
        <p:nvSpPr>
          <p:cNvPr id="8" name="文本框 2">
            <a:extLst>
              <a:ext uri="{FF2B5EF4-FFF2-40B4-BE49-F238E27FC236}">
                <a16:creationId xmlns:a16="http://schemas.microsoft.com/office/drawing/2014/main" id="{7C2E901A-C926-5C4E-BD41-FE2ED1F8D23F}"/>
              </a:ext>
            </a:extLst>
          </p:cNvPr>
          <p:cNvSpPr txBox="1"/>
          <p:nvPr/>
        </p:nvSpPr>
        <p:spPr>
          <a:xfrm>
            <a:off x="170329" y="6670912"/>
            <a:ext cx="66876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2</a:t>
            </a:r>
            <a:r>
              <a:rPr lang="en-US" sz="1200" dirty="0"/>
              <a:t>. RFLP analysis of SpCas9 activity in rice protoplasts under different temperatures. (</a:t>
            </a:r>
            <a:r>
              <a:rPr lang="en-US" sz="1200" b="1" dirty="0"/>
              <a:t>a</a:t>
            </a:r>
            <a:r>
              <a:rPr lang="en-US" sz="1200" dirty="0"/>
              <a:t>) and (</a:t>
            </a:r>
            <a:r>
              <a:rPr lang="en-US" sz="1200" b="1" dirty="0"/>
              <a:t>b</a:t>
            </a:r>
            <a:r>
              <a:rPr lang="en-US" sz="1200" dirty="0"/>
              <a:t>) RFLP analysis of </a:t>
            </a:r>
            <a:r>
              <a:rPr lang="en-US" sz="1200" i="1" dirty="0" err="1"/>
              <a:t>OsPDS</a:t>
            </a:r>
            <a:r>
              <a:rPr lang="en-US" sz="1200" dirty="0"/>
              <a:t> mutated by SpCas9 at four different temperatures. WT control with and without enzyme digestion were included.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074A7F0-1845-2F42-9B9D-28EDB5706BEA}"/>
              </a:ext>
            </a:extLst>
          </p:cNvPr>
          <p:cNvSpPr txBox="1"/>
          <p:nvPr/>
        </p:nvSpPr>
        <p:spPr>
          <a:xfrm>
            <a:off x="946384" y="1098363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DEB67E8-BAFE-364D-97F6-F100F8AC2CA3}"/>
              </a:ext>
            </a:extLst>
          </p:cNvPr>
          <p:cNvSpPr txBox="1"/>
          <p:nvPr/>
        </p:nvSpPr>
        <p:spPr>
          <a:xfrm>
            <a:off x="946384" y="380663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384305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2253059-6381-7440-93C4-30883631D7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4079" y="655882"/>
            <a:ext cx="2384612" cy="253769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4836E74-D343-3547-8583-9F8902F47F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3794" y="655883"/>
            <a:ext cx="2398218" cy="2537690"/>
          </a:xfrm>
          <a:prstGeom prst="rect">
            <a:avLst/>
          </a:prstGeom>
        </p:spPr>
      </p:pic>
      <p:pic>
        <p:nvPicPr>
          <p:cNvPr id="6" name="图片 1">
            <a:extLst>
              <a:ext uri="{FF2B5EF4-FFF2-40B4-BE49-F238E27FC236}">
                <a16:creationId xmlns:a16="http://schemas.microsoft.com/office/drawing/2014/main" id="{01C950EE-3821-C24F-AF67-B6B31C65667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207" t="2511" r="3331" b="4840"/>
          <a:stretch/>
        </p:blipFill>
        <p:spPr>
          <a:xfrm>
            <a:off x="2019298" y="3724276"/>
            <a:ext cx="2782042" cy="2880000"/>
          </a:xfrm>
          <a:prstGeom prst="rect">
            <a:avLst/>
          </a:prstGeom>
        </p:spPr>
      </p:pic>
      <p:sp>
        <p:nvSpPr>
          <p:cNvPr id="8" name="文本框 2">
            <a:extLst>
              <a:ext uri="{FF2B5EF4-FFF2-40B4-BE49-F238E27FC236}">
                <a16:creationId xmlns:a16="http://schemas.microsoft.com/office/drawing/2014/main" id="{0DE83BBB-57B7-4B48-B2D8-66AB1A0062A7}"/>
              </a:ext>
            </a:extLst>
          </p:cNvPr>
          <p:cNvSpPr txBox="1"/>
          <p:nvPr/>
        </p:nvSpPr>
        <p:spPr>
          <a:xfrm>
            <a:off x="163223" y="7560148"/>
            <a:ext cx="653155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3</a:t>
            </a:r>
            <a:r>
              <a:rPr lang="en-US" sz="1200" dirty="0"/>
              <a:t>. Measurement of rice protoplast transfection efficiencies using GFP construct at different temperatures. (</a:t>
            </a:r>
            <a:r>
              <a:rPr lang="en-US" sz="1200" b="1" dirty="0"/>
              <a:t>a</a:t>
            </a:r>
            <a:r>
              <a:rPr lang="en-US" sz="1200" dirty="0"/>
              <a:t>) Transfected protoplasts depicted under visible light and fluorescent microscopy. (</a:t>
            </a:r>
            <a:r>
              <a:rPr lang="en-US" sz="1200" b="1" dirty="0"/>
              <a:t>b</a:t>
            </a:r>
            <a:r>
              <a:rPr lang="en-US" sz="1200" dirty="0"/>
              <a:t>) Transfection efficiency at four different temperatures. Error bars represent standard deviations of two biological replicates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5AA07E4-EEC2-E343-BFAE-24061F86C75C}"/>
              </a:ext>
            </a:extLst>
          </p:cNvPr>
          <p:cNvSpPr txBox="1"/>
          <p:nvPr/>
        </p:nvSpPr>
        <p:spPr>
          <a:xfrm>
            <a:off x="594244" y="286550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3B31F47-BFC3-D24C-BD0C-0BB2094F1776}"/>
              </a:ext>
            </a:extLst>
          </p:cNvPr>
          <p:cNvSpPr txBox="1"/>
          <p:nvPr/>
        </p:nvSpPr>
        <p:spPr>
          <a:xfrm>
            <a:off x="666940" y="323476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668617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61D48DF-EB05-471F-B259-B72022C7BC6A}"/>
              </a:ext>
            </a:extLst>
          </p:cNvPr>
          <p:cNvSpPr txBox="1"/>
          <p:nvPr/>
        </p:nvSpPr>
        <p:spPr>
          <a:xfrm>
            <a:off x="85435" y="8243007"/>
            <a:ext cx="67178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4</a:t>
            </a:r>
            <a:r>
              <a:rPr lang="en-US" sz="1200" dirty="0"/>
              <a:t>. Three Cas12a nucleases generate slightly distinct mutation profiles at </a:t>
            </a:r>
            <a:r>
              <a:rPr lang="en-US" sz="1200" i="1" dirty="0"/>
              <a:t>OsROC5</a:t>
            </a:r>
            <a:r>
              <a:rPr lang="en-US" sz="1200" dirty="0"/>
              <a:t> site which are unaffected by temperature. </a:t>
            </a:r>
            <a:r>
              <a:rPr lang="en-US" sz="1200" i="1" dirty="0"/>
              <a:t>OsROC5</a:t>
            </a:r>
            <a:r>
              <a:rPr lang="en-US" sz="1200" dirty="0"/>
              <a:t> gene targeted by AsCas12a (</a:t>
            </a:r>
            <a:r>
              <a:rPr lang="en-US" sz="1200" b="1" dirty="0"/>
              <a:t>a</a:t>
            </a:r>
            <a:r>
              <a:rPr lang="en-US" sz="1200" dirty="0"/>
              <a:t>), FnCas12a (</a:t>
            </a:r>
            <a:r>
              <a:rPr lang="en-US" sz="1200" b="1" dirty="0"/>
              <a:t>b</a:t>
            </a:r>
            <a:r>
              <a:rPr lang="en-US" sz="1200" dirty="0"/>
              <a:t>) and LbCas12a (</a:t>
            </a:r>
            <a:r>
              <a:rPr lang="en-US" sz="1200" b="1" dirty="0"/>
              <a:t>c</a:t>
            </a:r>
            <a:r>
              <a:rPr lang="en-US" sz="1200" dirty="0"/>
              <a:t>). PAM is red, crRNA is blue. Error bars represent standard deviations of two biological replicates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ED1E48F-275D-4811-A71E-14F9D184D02F}"/>
              </a:ext>
            </a:extLst>
          </p:cNvPr>
          <p:cNvSpPr txBox="1"/>
          <p:nvPr/>
        </p:nvSpPr>
        <p:spPr>
          <a:xfrm>
            <a:off x="204397" y="79248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E9F293A-E952-47D1-946F-8CF51B09C5B9}"/>
              </a:ext>
            </a:extLst>
          </p:cNvPr>
          <p:cNvSpPr txBox="1"/>
          <p:nvPr/>
        </p:nvSpPr>
        <p:spPr>
          <a:xfrm>
            <a:off x="124432" y="267000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A2B52B-7D4C-4C17-8A21-60ADA67CBC17}"/>
              </a:ext>
            </a:extLst>
          </p:cNvPr>
          <p:cNvSpPr txBox="1"/>
          <p:nvPr/>
        </p:nvSpPr>
        <p:spPr>
          <a:xfrm>
            <a:off x="162532" y="5425647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941D49B-FCC1-464C-8B42-E672FBE4E0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4605" y="146595"/>
            <a:ext cx="5628790" cy="7820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53734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2513B41-0228-4148-B6BA-3A092B249CDD}"/>
              </a:ext>
            </a:extLst>
          </p:cNvPr>
          <p:cNvSpPr txBox="1"/>
          <p:nvPr/>
        </p:nvSpPr>
        <p:spPr>
          <a:xfrm>
            <a:off x="211873" y="6135647"/>
            <a:ext cx="65569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5</a:t>
            </a:r>
            <a:r>
              <a:rPr lang="en-US" sz="1200" dirty="0"/>
              <a:t>. Mutation profiles by SpCas9 are largely unaffected by temperature. SpCas9 targeting </a:t>
            </a:r>
            <a:r>
              <a:rPr lang="en-US" sz="1200" i="1" dirty="0" err="1"/>
              <a:t>OsPDS</a:t>
            </a:r>
            <a:r>
              <a:rPr lang="en-US" sz="1200" dirty="0"/>
              <a:t>. PAM is red, crRNA is blue. Error bars represent standard deviations of two biological replicates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6B49FD2-9225-48D1-9FBB-674ADAE388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8255" y="2009775"/>
            <a:ext cx="6107698" cy="2907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59078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2">
            <a:extLst>
              <a:ext uri="{FF2B5EF4-FFF2-40B4-BE49-F238E27FC236}">
                <a16:creationId xmlns:a16="http://schemas.microsoft.com/office/drawing/2014/main" id="{DC193FAC-19BC-4A56-9669-CC9601E4CE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495" y="1383967"/>
            <a:ext cx="3084505" cy="1233802"/>
          </a:xfrm>
          <a:prstGeom prst="rect">
            <a:avLst/>
          </a:prstGeom>
        </p:spPr>
      </p:pic>
      <p:pic>
        <p:nvPicPr>
          <p:cNvPr id="5" name="图片 7">
            <a:extLst>
              <a:ext uri="{FF2B5EF4-FFF2-40B4-BE49-F238E27FC236}">
                <a16:creationId xmlns:a16="http://schemas.microsoft.com/office/drawing/2014/main" id="{3CB502C8-25FD-46CC-8ACE-F81D77FC84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1383967"/>
            <a:ext cx="3084505" cy="1233802"/>
          </a:xfrm>
          <a:prstGeom prst="rect">
            <a:avLst/>
          </a:prstGeom>
        </p:spPr>
      </p:pic>
      <p:pic>
        <p:nvPicPr>
          <p:cNvPr id="6" name="图片 9">
            <a:extLst>
              <a:ext uri="{FF2B5EF4-FFF2-40B4-BE49-F238E27FC236}">
                <a16:creationId xmlns:a16="http://schemas.microsoft.com/office/drawing/2014/main" id="{8774E8CB-58CB-43F0-BAD9-D30E4A7476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4495" y="2813167"/>
            <a:ext cx="2491201" cy="1237173"/>
          </a:xfrm>
          <a:prstGeom prst="rect">
            <a:avLst/>
          </a:prstGeom>
        </p:spPr>
      </p:pic>
      <p:pic>
        <p:nvPicPr>
          <p:cNvPr id="7" name="图片 11">
            <a:extLst>
              <a:ext uri="{FF2B5EF4-FFF2-40B4-BE49-F238E27FC236}">
                <a16:creationId xmlns:a16="http://schemas.microsoft.com/office/drawing/2014/main" id="{04377DF0-788B-4D29-8BEF-93C7F7B5A4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4382" y="4984403"/>
            <a:ext cx="3094618" cy="1243915"/>
          </a:xfrm>
          <a:prstGeom prst="rect">
            <a:avLst/>
          </a:prstGeom>
        </p:spPr>
      </p:pic>
      <p:pic>
        <p:nvPicPr>
          <p:cNvPr id="8" name="图片 13">
            <a:extLst>
              <a:ext uri="{FF2B5EF4-FFF2-40B4-BE49-F238E27FC236}">
                <a16:creationId xmlns:a16="http://schemas.microsoft.com/office/drawing/2014/main" id="{E8BD61E2-C990-4FF9-89AC-DC3023B621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29000" y="4984402"/>
            <a:ext cx="1901268" cy="124391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4BD4144-3B44-42FA-AA98-9D0564F4261C}"/>
              </a:ext>
            </a:extLst>
          </p:cNvPr>
          <p:cNvSpPr txBox="1"/>
          <p:nvPr/>
        </p:nvSpPr>
        <p:spPr>
          <a:xfrm>
            <a:off x="172318" y="1027528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571018C-648F-4811-BB06-15DD48D66F6E}"/>
              </a:ext>
            </a:extLst>
          </p:cNvPr>
          <p:cNvSpPr txBox="1"/>
          <p:nvPr/>
        </p:nvSpPr>
        <p:spPr>
          <a:xfrm>
            <a:off x="162654" y="461507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2" name="TextBox 64">
            <a:extLst>
              <a:ext uri="{FF2B5EF4-FFF2-40B4-BE49-F238E27FC236}">
                <a16:creationId xmlns:a16="http://schemas.microsoft.com/office/drawing/2014/main" id="{6B3F4CBD-DF32-4BFF-A232-100E04296AA3}"/>
              </a:ext>
            </a:extLst>
          </p:cNvPr>
          <p:cNvSpPr txBox="1"/>
          <p:nvPr/>
        </p:nvSpPr>
        <p:spPr>
          <a:xfrm>
            <a:off x="162654" y="6812426"/>
            <a:ext cx="65615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6</a:t>
            </a:r>
            <a:r>
              <a:rPr lang="en-US" sz="1200" dirty="0"/>
              <a:t>. RFLP analysis of T0 mutant lines by AsCas12a. Twenty-seven T0 lines targeting </a:t>
            </a:r>
            <a:r>
              <a:rPr lang="en-US" sz="1200" i="1" dirty="0"/>
              <a:t>OsDEP1 </a:t>
            </a:r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). and 14 T0 lines targeting </a:t>
            </a:r>
            <a:r>
              <a:rPr lang="en-US" sz="1200" i="1" dirty="0"/>
              <a:t>OsROC5</a:t>
            </a:r>
            <a:r>
              <a:rPr lang="en-US" sz="1200" dirty="0"/>
              <a:t> (</a:t>
            </a:r>
            <a:r>
              <a:rPr lang="en-US" sz="1200" b="1" dirty="0"/>
              <a:t>b</a:t>
            </a:r>
            <a:r>
              <a:rPr lang="en-US" sz="1200" dirty="0"/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1931487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EE8EC6C-941F-470E-87FD-8B0937286388}"/>
              </a:ext>
            </a:extLst>
          </p:cNvPr>
          <p:cNvSpPr txBox="1"/>
          <p:nvPr/>
        </p:nvSpPr>
        <p:spPr>
          <a:xfrm>
            <a:off x="211873" y="7038818"/>
            <a:ext cx="649001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7. </a:t>
            </a:r>
            <a:r>
              <a:rPr lang="en-US" sz="1200" dirty="0"/>
              <a:t>Late treatment of high temperature is ineffective on promoting LbCas12a induced mutations in </a:t>
            </a:r>
            <a:r>
              <a:rPr lang="en-US" sz="1200" i="1" dirty="0"/>
              <a:t>Arabidopsis.</a:t>
            </a:r>
            <a:r>
              <a:rPr lang="en-US" sz="1200" dirty="0"/>
              <a:t> Agarose gels and graph of percent mutations from </a:t>
            </a:r>
            <a:r>
              <a:rPr lang="en-US" sz="1200" i="1" dirty="0"/>
              <a:t>GL2</a:t>
            </a:r>
            <a:r>
              <a:rPr lang="en-US" sz="1200" dirty="0"/>
              <a:t> plants (</a:t>
            </a:r>
            <a:r>
              <a:rPr lang="en-US" sz="1200" b="1" dirty="0"/>
              <a:t>a</a:t>
            </a:r>
            <a:r>
              <a:rPr lang="en-US" sz="1200" dirty="0"/>
              <a:t>) and </a:t>
            </a:r>
            <a:r>
              <a:rPr lang="en-US" sz="1200" i="1" dirty="0"/>
              <a:t>TT4</a:t>
            </a:r>
            <a:r>
              <a:rPr lang="en-US" sz="1200" dirty="0"/>
              <a:t> plants (</a:t>
            </a:r>
            <a:r>
              <a:rPr lang="en-US" sz="1200" b="1" dirty="0"/>
              <a:t>b</a:t>
            </a:r>
            <a:r>
              <a:rPr lang="en-US" sz="1200" dirty="0"/>
              <a:t>), heat treated for two consecutive weeks after bolting. Error bars represent standard deviations.</a:t>
            </a:r>
          </a:p>
          <a:p>
            <a:pPr defTabSz="342900"/>
            <a:endParaRPr lang="en-US" sz="12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1097BA8-097B-4BFF-AB76-0FB74846AF03}"/>
              </a:ext>
            </a:extLst>
          </p:cNvPr>
          <p:cNvSpPr txBox="1"/>
          <p:nvPr/>
        </p:nvSpPr>
        <p:spPr>
          <a:xfrm>
            <a:off x="546370" y="1647867"/>
            <a:ext cx="614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b="1" dirty="0">
                <a:solidFill>
                  <a:prstClr val="black"/>
                </a:solidFill>
                <a:latin typeface="Calibri" panose="020F0502020204030204"/>
              </a:rPr>
              <a:t>a</a:t>
            </a:r>
          </a:p>
        </p:txBody>
      </p:sp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207674E6-A657-40C0-B251-46495F90A2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7130481"/>
              </p:ext>
            </p:extLst>
          </p:nvPr>
        </p:nvGraphicFramePr>
        <p:xfrm>
          <a:off x="4332563" y="1365811"/>
          <a:ext cx="2039419" cy="22291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FF4F428F-4421-4697-AD93-FB2C369357E8}"/>
              </a:ext>
            </a:extLst>
          </p:cNvPr>
          <p:cNvSpPr txBox="1"/>
          <p:nvPr/>
        </p:nvSpPr>
        <p:spPr>
          <a:xfrm>
            <a:off x="546369" y="3847653"/>
            <a:ext cx="340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b="1" dirty="0">
                <a:solidFill>
                  <a:prstClr val="black"/>
                </a:solidFill>
                <a:latin typeface="Calibri" panose="020F0502020204030204"/>
              </a:rPr>
              <a:t>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9C45FC3-CDC4-46D3-A708-6090E0997F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0678" y="1722157"/>
            <a:ext cx="2686050" cy="160972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D4CC148-834E-4A54-894B-A9CDC6996C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3797" y="4032319"/>
            <a:ext cx="2676525" cy="1981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83892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C209571-6790-E14A-8770-C3AFD8AC92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5350" y="3579416"/>
            <a:ext cx="3991901" cy="143708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014DA6D-5483-2640-AF37-64989E9C7B6F}"/>
              </a:ext>
            </a:extLst>
          </p:cNvPr>
          <p:cNvSpPr txBox="1"/>
          <p:nvPr/>
        </p:nvSpPr>
        <p:spPr>
          <a:xfrm>
            <a:off x="555301" y="875762"/>
            <a:ext cx="614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b="1" dirty="0">
                <a:solidFill>
                  <a:prstClr val="black"/>
                </a:solidFill>
                <a:latin typeface="Calibri" panose="020F0502020204030204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2BB585-F3F3-8446-B1F4-BD18F94DACBC}"/>
              </a:ext>
            </a:extLst>
          </p:cNvPr>
          <p:cNvSpPr txBox="1"/>
          <p:nvPr/>
        </p:nvSpPr>
        <p:spPr>
          <a:xfrm>
            <a:off x="555301" y="3501232"/>
            <a:ext cx="340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b="1" dirty="0">
                <a:solidFill>
                  <a:prstClr val="black"/>
                </a:solidFill>
                <a:latin typeface="Calibri" panose="020F0502020204030204"/>
              </a:rPr>
              <a:t>b</a:t>
            </a:r>
          </a:p>
        </p:txBody>
      </p:sp>
      <p:sp>
        <p:nvSpPr>
          <p:cNvPr id="7" name="文本框 2">
            <a:extLst>
              <a:ext uri="{FF2B5EF4-FFF2-40B4-BE49-F238E27FC236}">
                <a16:creationId xmlns:a16="http://schemas.microsoft.com/office/drawing/2014/main" id="{6CF4A2BA-4E3F-DA4D-85A0-F5AD0EBA854D}"/>
              </a:ext>
            </a:extLst>
          </p:cNvPr>
          <p:cNvSpPr txBox="1"/>
          <p:nvPr/>
        </p:nvSpPr>
        <p:spPr>
          <a:xfrm>
            <a:off x="170329" y="6670912"/>
            <a:ext cx="636382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8</a:t>
            </a:r>
            <a:r>
              <a:rPr lang="en-US" sz="1200" dirty="0"/>
              <a:t>. Analysis of AsCas12a mediated mutagenesis at the </a:t>
            </a:r>
            <a:r>
              <a:rPr lang="en-US" sz="1200" i="1" dirty="0"/>
              <a:t>TT4</a:t>
            </a:r>
            <a:r>
              <a:rPr lang="en-US" sz="1200" dirty="0"/>
              <a:t> locus in Arabidopsis protoplasts. (</a:t>
            </a:r>
            <a:r>
              <a:rPr lang="en-US" sz="1200" b="1" dirty="0"/>
              <a:t>a</a:t>
            </a:r>
            <a:r>
              <a:rPr lang="en-US" sz="1200" dirty="0"/>
              <a:t>) Mutation frequency of </a:t>
            </a:r>
            <a:r>
              <a:rPr lang="en-US" sz="1200" i="1" dirty="0"/>
              <a:t>TT4</a:t>
            </a:r>
            <a:r>
              <a:rPr lang="en-US" sz="1200" dirty="0"/>
              <a:t> by LbCas12a at 22℃ and 29℃, quantified by RFLP analysis. Error bars represent standard deviations of two biological replicates. (</a:t>
            </a:r>
            <a:r>
              <a:rPr lang="en-US" sz="1200" b="1" dirty="0"/>
              <a:t>b</a:t>
            </a:r>
            <a:r>
              <a:rPr lang="en-US" sz="1200" dirty="0"/>
              <a:t>) RFLP analysis of </a:t>
            </a:r>
            <a:r>
              <a:rPr lang="en-US" sz="1200" i="1" dirty="0"/>
              <a:t>TT4</a:t>
            </a:r>
            <a:r>
              <a:rPr lang="en-US" sz="1200" dirty="0"/>
              <a:t> mutated by AsCas12a at 22℃ and 29℃. ND: non-detectable activity. WT control with and without enzyme digestion were included. 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8C60D1A7-34FE-C746-B100-63A381BB67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2502338"/>
              </p:ext>
            </p:extLst>
          </p:nvPr>
        </p:nvGraphicFramePr>
        <p:xfrm>
          <a:off x="1404126" y="982269"/>
          <a:ext cx="2024874" cy="22376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7369553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3DDFFE2-0F8D-420B-AACF-9620AA493E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0640802"/>
              </p:ext>
            </p:extLst>
          </p:nvPr>
        </p:nvGraphicFramePr>
        <p:xfrm>
          <a:off x="755154" y="2968835"/>
          <a:ext cx="5556272" cy="2870216"/>
        </p:xfrm>
        <a:graphic>
          <a:graphicData uri="http://schemas.openxmlformats.org/drawingml/2006/table">
            <a:tbl>
              <a:tblPr firstRow="1" firstCol="1" bandRow="1"/>
              <a:tblGrid>
                <a:gridCol w="6911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3350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1241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905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286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842B-5-1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l2 sequence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Indel size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enotype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#T1 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1: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AA</a:t>
                      </a:r>
                      <a:r>
                        <a:rPr lang="en-US" sz="600" b="1">
                          <a:solidFill>
                            <a:srgbClr val="FFFFFF"/>
                          </a:solidFill>
                          <a:effectLst/>
                          <a:highlight>
                            <a:srgbClr val="0000FF"/>
                          </a:highlight>
                          <a:latin typeface="Courier New"/>
                          <a:ea typeface="Malgun Gothic"/>
                          <a:cs typeface="Times New Roman"/>
                        </a:rPr>
                        <a:t>A</a:t>
                      </a:r>
                      <a:r>
                        <a:rPr lang="en-US" sz="600" b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T</a:t>
                      </a:r>
                      <a:r>
                        <a:rPr lang="en-US" sz="600" b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      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+1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B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2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2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A</a:t>
                      </a:r>
                      <a:r>
                        <a:rPr lang="en-US" sz="600" b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-------GGGCTGGC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8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1:   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AA</a:t>
                      </a:r>
                      <a:r>
                        <a:rPr lang="en-US" sz="600" b="1" dirty="0">
                          <a:solidFill>
                            <a:srgbClr val="FFFFFF"/>
                          </a:solidFill>
                          <a:effectLst/>
                          <a:highlight>
                            <a:srgbClr val="0000FF"/>
                          </a:highlight>
                          <a:latin typeface="Courier New"/>
                          <a:ea typeface="Malgun Gothic"/>
                          <a:cs typeface="Times New Roman"/>
                        </a:rPr>
                        <a:t>A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T</a:t>
                      </a:r>
                      <a:r>
                        <a:rPr lang="en-US" sz="6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      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+1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B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2: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</a:t>
                      </a:r>
                      <a:r>
                        <a:rPr lang="en-US" sz="600" b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-----CGGTGGGCTGGC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6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1:   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AA</a:t>
                      </a:r>
                      <a:r>
                        <a:rPr lang="en-US" sz="600" b="1">
                          <a:solidFill>
                            <a:srgbClr val="FFFFFF"/>
                          </a:solidFill>
                          <a:effectLst/>
                          <a:highlight>
                            <a:srgbClr val="0000FF"/>
                          </a:highlight>
                          <a:latin typeface="Courier New"/>
                          <a:ea typeface="Malgun Gothic"/>
                          <a:cs typeface="Times New Roman"/>
                        </a:rPr>
                        <a:t>NN</a:t>
                      </a:r>
                      <a:r>
                        <a:rPr lang="en-US" sz="600" b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T</a:t>
                      </a:r>
                      <a:r>
                        <a:rPr lang="en-US" sz="600" b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      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+2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B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1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2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-</a:t>
                      </a:r>
                      <a:r>
                        <a:rPr lang="en-US" sz="6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-----GTGGGCTGGC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7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1:   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AA</a:t>
                      </a:r>
                      <a:r>
                        <a:rPr lang="en-US" sz="600" b="1" dirty="0">
                          <a:solidFill>
                            <a:srgbClr val="FFFFFF"/>
                          </a:solidFill>
                          <a:effectLst/>
                          <a:highlight>
                            <a:srgbClr val="0000FF"/>
                          </a:highlight>
                          <a:latin typeface="Courier New"/>
                          <a:ea typeface="Malgun Gothic"/>
                          <a:cs typeface="Times New Roman"/>
                        </a:rPr>
                        <a:t>NN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T</a:t>
                      </a:r>
                      <a:r>
                        <a:rPr lang="en-US" sz="6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      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+2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B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2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2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-</a:t>
                      </a:r>
                      <a:r>
                        <a:rPr lang="en-US" sz="6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-----GCGGTGGGCTGGC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7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1:   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AA</a:t>
                      </a:r>
                      <a:r>
                        <a:rPr lang="en-US" sz="600" b="1" dirty="0">
                          <a:solidFill>
                            <a:srgbClr val="FFFFFF"/>
                          </a:solidFill>
                          <a:effectLst/>
                          <a:highlight>
                            <a:srgbClr val="0000FF"/>
                          </a:highlight>
                          <a:latin typeface="Courier New"/>
                          <a:ea typeface="Malgun Gothic"/>
                          <a:cs typeface="Times New Roman"/>
                        </a:rPr>
                        <a:t>NNN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T</a:t>
                      </a:r>
                      <a:r>
                        <a:rPr lang="en-US" sz="6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      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+3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B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3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2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</a:t>
                      </a:r>
                      <a:r>
                        <a:rPr lang="en-US" sz="600" b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-----GCGGTGGGCTGGC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6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1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AAAT</a:t>
                      </a:r>
                      <a:r>
                        <a:rPr lang="en-US" sz="600" b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    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0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M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14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2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-------T</a:t>
                      </a:r>
                      <a:r>
                        <a:rPr lang="en-US" sz="6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7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1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AAAT</a:t>
                      </a:r>
                      <a:r>
                        <a:rPr lang="en-US" sz="600" b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    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0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M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7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2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---------</a:t>
                      </a:r>
                      <a:r>
                        <a:rPr lang="en-US" sz="6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9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1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AAAT</a:t>
                      </a:r>
                      <a:r>
                        <a:rPr lang="en-US" sz="600" b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    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0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/>
                          <a:ea typeface="Malgun Gothic"/>
                          <a:cs typeface="Times New Roman"/>
                        </a:rPr>
                        <a:t>M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2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------</a:t>
                      </a:r>
                      <a:r>
                        <a:rPr lang="en-US" sz="6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--GTGGGCTGGC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9 bp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1: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 err="1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 dirty="0" err="1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fATCACAAACTTCAAAT</a:t>
                      </a:r>
                      <a:r>
                        <a:rPr lang="en-US" sz="600" b="1" dirty="0" err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CGGTGGGCTGGC</a:t>
                      </a:r>
                      <a:r>
                        <a:rPr lang="en-US" sz="6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    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0 bp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/>
                          <a:ea typeface="Malgun Gothic"/>
                          <a:cs typeface="Times New Roman"/>
                        </a:rPr>
                        <a:t>M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1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5106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Allele2: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GTCACAGATCACAAACTTC-----</a:t>
                      </a:r>
                      <a:r>
                        <a:rPr lang="en-US" sz="600" b="1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---GGGCTGGC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-9 </a:t>
                      </a:r>
                      <a:r>
                        <a:rPr lang="en-US" sz="800" dirty="0" err="1">
                          <a:effectLst/>
                          <a:latin typeface="Courier New"/>
                          <a:ea typeface="Malgun Gothic"/>
                          <a:cs typeface="Times New Roman"/>
                        </a:rPr>
                        <a:t>bp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B528607D-D32A-40B1-9E6E-3E3D7FCEAE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1758402"/>
              </p:ext>
            </p:extLst>
          </p:nvPr>
        </p:nvGraphicFramePr>
        <p:xfrm>
          <a:off x="755154" y="318606"/>
          <a:ext cx="5556272" cy="1571369"/>
        </p:xfrm>
        <a:graphic>
          <a:graphicData uri="http://schemas.openxmlformats.org/drawingml/2006/table">
            <a:tbl>
              <a:tblPr firstRow="1" firstCol="1" bandRow="1"/>
              <a:tblGrid>
                <a:gridCol w="73399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68279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334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334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260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564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842B-2-2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l2 sequence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Indel size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enotype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#T1 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4367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llele1: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TCACAGATCACAAACTTCAA</a:t>
                      </a:r>
                      <a:r>
                        <a:rPr lang="en-US" sz="600" b="1" dirty="0">
                          <a:solidFill>
                            <a:srgbClr val="FFFFFF"/>
                          </a:solidFill>
                          <a:effectLst/>
                          <a:highlight>
                            <a:srgbClr val="0000FF"/>
                          </a:highlight>
                          <a:latin typeface="Courier New"/>
                          <a:ea typeface="Malgun Gothic"/>
                          <a:cs typeface="Times New Roman"/>
                        </a:rPr>
                        <a:t>N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T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CGGTGGGCTGGC      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+1 bp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B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3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827411"/>
                  </a:ext>
                </a:extLst>
              </a:tr>
              <a:tr h="164367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llele2: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TCACAGATCACAAACTTCAA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----------CTGGC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-10 </a:t>
                      </a: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bp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5427066"/>
                  </a:ext>
                </a:extLst>
              </a:tr>
              <a:tr h="164367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llele1: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TCACAGATCACAAACTTCAA</a:t>
                      </a:r>
                      <a:r>
                        <a:rPr lang="en-US" sz="600" b="1" dirty="0">
                          <a:solidFill>
                            <a:srgbClr val="FFFFFF"/>
                          </a:solidFill>
                          <a:effectLst/>
                          <a:highlight>
                            <a:srgbClr val="0000FF"/>
                          </a:highlight>
                          <a:latin typeface="Courier New"/>
                          <a:ea typeface="Malgun Gothic"/>
                          <a:cs typeface="Times New Roman"/>
                        </a:rPr>
                        <a:t>N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T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CGGTGGGCTGGC      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+1 </a:t>
                      </a: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bp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B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363365"/>
                  </a:ext>
                </a:extLst>
              </a:tr>
              <a:tr h="164367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llele2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TCACAGATCACA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----------GCGGTGGGCTGGC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-10 bp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1035858"/>
                  </a:ext>
                </a:extLst>
              </a:tr>
              <a:tr h="164367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llele1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TCACAGATCACAAACTTCAAAT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CGGTGGGCTGGC    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0 bp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M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14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1988106"/>
                  </a:ext>
                </a:extLst>
              </a:tr>
              <a:tr h="164367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llele2:</a:t>
                      </a:r>
                      <a:endParaRPr lang="en-US" sz="60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TCACAGATCACA-----------</a:t>
                      </a:r>
                      <a:r>
                        <a:rPr lang="en-US" sz="600" b="1" dirty="0">
                          <a:solidFill>
                            <a:schemeClr val="tx1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CG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TGGGCTGGC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-11 bp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5651327"/>
                  </a:ext>
                </a:extLst>
              </a:tr>
              <a:tr h="164367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llele1: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TCACAGATCACAAACTTCAAAT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CGGTGGGCTGGC    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0 bp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W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17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6301034"/>
                  </a:ext>
                </a:extLst>
              </a:tr>
              <a:tr h="164367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Allele2: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TTTG</a:t>
                      </a:r>
                      <a:r>
                        <a:rPr lang="en-US" sz="600" b="1" dirty="0">
                          <a:solidFill>
                            <a:srgbClr val="0000FF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TCACAGATCACAAACTTCAAAT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GCGGTGGGCTGGC    </a:t>
                      </a:r>
                      <a:endParaRPr lang="en-US" sz="6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0 </a:t>
                      </a: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Times New Roman"/>
                          <a:cs typeface="Times New Roman"/>
                        </a:rPr>
                        <a:t>bp</a:t>
                      </a:r>
                      <a:endParaRPr lang="en-US" sz="800" dirty="0">
                        <a:effectLst/>
                        <a:latin typeface="Calibri"/>
                        <a:ea typeface="Malgun Gothic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2360788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3739DA84-2771-44A5-B559-36EA68E91D49}"/>
              </a:ext>
            </a:extLst>
          </p:cNvPr>
          <p:cNvSpPr txBox="1"/>
          <p:nvPr/>
        </p:nvSpPr>
        <p:spPr>
          <a:xfrm>
            <a:off x="304756" y="130048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B8E538F-B790-4F66-AE0C-29A1456FDA85}"/>
              </a:ext>
            </a:extLst>
          </p:cNvPr>
          <p:cNvSpPr txBox="1"/>
          <p:nvPr/>
        </p:nvSpPr>
        <p:spPr>
          <a:xfrm>
            <a:off x="363059" y="261590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FB8AF9-9430-4302-8411-4B2829EBB7E4}"/>
              </a:ext>
            </a:extLst>
          </p:cNvPr>
          <p:cNvSpPr txBox="1"/>
          <p:nvPr/>
        </p:nvSpPr>
        <p:spPr>
          <a:xfrm>
            <a:off x="223573" y="7259626"/>
            <a:ext cx="642255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9</a:t>
            </a:r>
            <a:r>
              <a:rPr lang="en-US" sz="1200" dirty="0"/>
              <a:t>. Genotyping results of T1 maize lines.</a:t>
            </a:r>
            <a:r>
              <a:rPr lang="en-US" sz="1200" b="1" dirty="0"/>
              <a:t> a </a:t>
            </a:r>
            <a:r>
              <a:rPr lang="en-US" sz="1200" dirty="0"/>
              <a:t>Genotypes of 35 T1 lines from A842B-2-2 (0 bp, -11 bp). </a:t>
            </a:r>
            <a:r>
              <a:rPr lang="en-US" sz="1200" b="1" dirty="0"/>
              <a:t>b</a:t>
            </a:r>
            <a:r>
              <a:rPr lang="en-US" sz="1200" dirty="0"/>
              <a:t> Genotypes of 32 T1 lines from A842B-5-1(0 bp, +1 bp). Red letters ‘TTTG’ indicate PAM sequences for Cas12a; blue letters, target sequences in </a:t>
            </a:r>
            <a:r>
              <a:rPr lang="en-US" sz="1200" i="1" dirty="0"/>
              <a:t>GL2</a:t>
            </a:r>
            <a:r>
              <a:rPr lang="en-US" sz="1200" dirty="0"/>
              <a:t> exon 2; white letters in blue boxes, insertion mutations; dash lines, indels; #T1, number of T1 mutant lines carrying the mutant genotypes. B, biallelic; M, monoallelic; WT, wild type. The nucleotides with ambiguous base calling are indicated by ‘N’s.</a:t>
            </a:r>
          </a:p>
        </p:txBody>
      </p:sp>
    </p:spTree>
    <p:extLst>
      <p:ext uri="{BB962C8B-B14F-4D97-AF65-F5344CB8AC3E}">
        <p14:creationId xmlns:p14="http://schemas.microsoft.com/office/powerpoint/2010/main" val="2518601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65</TotalTime>
  <Words>890</Words>
  <Application>Microsoft Office PowerPoint</Application>
  <PresentationFormat>On-screen Show (4:3)</PresentationFormat>
  <Paragraphs>153</Paragraphs>
  <Slides>1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Courier New</vt:lpstr>
      <vt:lpstr>Office Theme</vt:lpstr>
      <vt:lpstr>1_Office Theme</vt:lpstr>
      <vt:lpstr>Workshe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iping Qi</cp:lastModifiedBy>
  <cp:revision>171</cp:revision>
  <dcterms:created xsi:type="dcterms:W3CDTF">2018-06-09T19:06:45Z</dcterms:created>
  <dcterms:modified xsi:type="dcterms:W3CDTF">2019-01-07T17:15:09Z</dcterms:modified>
</cp:coreProperties>
</file>